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B53FAD-D827-42CE-A757-EFAB291BC49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708C22-2AED-481A-AB82-59FE4DFBB1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981DB4-FE0C-4A4A-A621-5DE7B02BC71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9A52BC-A52C-4BFB-A8AC-0681B8114E1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6E1379-4737-45D1-8144-CDC6E3A234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BCFFE8-75AA-438F-B993-87C53C2C107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1CBC76-B242-4226-95A1-C88764E94D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2CC641-EB74-44EF-B597-80EA15324A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2D2F06-5E6B-45C6-A06A-DF3F33D1CA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F84279-5C1A-4991-ACE7-2DAC6FDBCE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275933-7542-407D-AE18-E22DA6655B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6684BB-D7E9-492E-ABE2-320197306B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52C64E4-1D83-499A-AA18-9F20FEE675A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ng"/><Relationship Id="rId3" Type="http://schemas.openxmlformats.org/officeDocument/2006/relationships/package" Target="../embeddings/oleObject2.xlsx"/><Relationship Id="rId4" Type="http://schemas.openxmlformats.org/officeDocument/2006/relationships/image" Target="../media/image2.png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 rot="16200000">
            <a:off x="-263160" y="6580080"/>
            <a:ext cx="1130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orMD scor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754200" y="5111640"/>
          <a:ext cx="6103800" cy="33688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54200" y="5111640"/>
                    <a:ext cx="6103800" cy="3368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44" name=""/>
          <p:cNvGrpSpPr/>
          <p:nvPr/>
        </p:nvGrpSpPr>
        <p:grpSpPr>
          <a:xfrm>
            <a:off x="612720" y="8462880"/>
            <a:ext cx="6075720" cy="246240"/>
            <a:chOff x="612720" y="8462880"/>
            <a:chExt cx="6075720" cy="246240"/>
          </a:xfrm>
        </p:grpSpPr>
        <p:sp>
          <p:nvSpPr>
            <p:cNvPr id="45" name=""/>
            <p:cNvSpPr/>
            <p:nvPr/>
          </p:nvSpPr>
          <p:spPr>
            <a:xfrm>
              <a:off x="612720" y="846288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088640" y="846288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1671480" y="846288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253960" y="846288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836440" y="846288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419280" y="846288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4001760" y="846288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584240" y="846288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5167080" y="846288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749560" y="846288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6332400" y="846288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6" name=""/>
          <p:cNvSpPr/>
          <p:nvPr/>
        </p:nvSpPr>
        <p:spPr>
          <a:xfrm>
            <a:off x="457200" y="82566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52080" y="790416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52080" y="755316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52080" y="720108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52080" y="685008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52080" y="614664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51000" y="5794200"/>
            <a:ext cx="358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52080" y="544356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52080" y="649764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52080" y="509256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2959920" y="8653320"/>
            <a:ext cx="93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PS scor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496600" y="4851360"/>
            <a:ext cx="1448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Additional  figur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2577600" y="0"/>
            <a:ext cx="1448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Additional  figur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9" name=""/>
          <p:cNvGrpSpPr/>
          <p:nvPr/>
        </p:nvGrpSpPr>
        <p:grpSpPr>
          <a:xfrm>
            <a:off x="355680" y="158760"/>
            <a:ext cx="6396120" cy="4257720"/>
            <a:chOff x="355680" y="158760"/>
            <a:chExt cx="6396120" cy="4257720"/>
          </a:xfrm>
        </p:grpSpPr>
        <p:graphicFrame>
          <p:nvGraphicFramePr>
            <p:cNvPr id="70" name=""/>
            <p:cNvGraphicFramePr/>
            <p:nvPr/>
          </p:nvGraphicFramePr>
          <p:xfrm>
            <a:off x="631800" y="158760"/>
            <a:ext cx="5553000" cy="4106880"/>
          </p:xfrm>
          <a:graphic>
            <a:graphicData uri="http://schemas.openxmlformats.org/presentationml/2006/ole">
              <p:oleObj progId="Excel.Sheet.12" r:id="rId3" spid="">
                <p:embed/>
                <p:pic>
                  <p:nvPicPr>
                    <p:cNvPr id="71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631800" y="158760"/>
                      <a:ext cx="5553000" cy="41068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72" name=""/>
            <p:cNvSpPr/>
            <p:nvPr/>
          </p:nvSpPr>
          <p:spPr>
            <a:xfrm rot="16200000">
              <a:off x="24840" y="1832760"/>
              <a:ext cx="938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PS scor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6211800" y="1852560"/>
              <a:ext cx="540000" cy="51120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6242040" y="2149200"/>
              <a:ext cx="50760" cy="49320"/>
            </a:xfrm>
            <a:custGeom>
              <a:avLst/>
              <a:gdLst/>
              <a:ahLst/>
              <a:rect l="l" t="t" r="r" b="b"/>
              <a:pathLst>
                <a:path w="32" h="31">
                  <a:moveTo>
                    <a:pt x="16" y="0"/>
                  </a:moveTo>
                  <a:lnTo>
                    <a:pt x="32" y="31"/>
                  </a:lnTo>
                  <a:lnTo>
                    <a:pt x="0" y="31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ff0000"/>
            </a:solidFill>
            <a:ln w="468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6311520" y="2124000"/>
              <a:ext cx="333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ummal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6242040" y="2027160"/>
              <a:ext cx="50760" cy="49320"/>
            </a:xfrm>
            <a:custGeom>
              <a:avLst/>
              <a:gdLst/>
              <a:ahLst/>
              <a:rect l="l" t="t" r="r" b="b"/>
              <a:pathLst>
                <a:path w="32" h="31">
                  <a:moveTo>
                    <a:pt x="16" y="0"/>
                  </a:moveTo>
                  <a:lnTo>
                    <a:pt x="32" y="31"/>
                  </a:lnTo>
                  <a:lnTo>
                    <a:pt x="0" y="31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rgbClr val="008080"/>
            </a:solidFill>
            <a:ln w="4680">
              <a:solidFill>
                <a:srgbClr val="0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6311520" y="2001600"/>
              <a:ext cx="3452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afft_linsi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6242040" y="2271600"/>
              <a:ext cx="44640" cy="44280"/>
            </a:xfrm>
            <a:prstGeom prst="ellipse">
              <a:avLst/>
            </a:prstGeom>
            <a:solidFill>
              <a:srgbClr val="800080"/>
            </a:solidFill>
            <a:ln w="46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480" bIns="-15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6311880" y="2246040"/>
              <a:ext cx="243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uscle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6242040" y="1901520"/>
              <a:ext cx="44640" cy="46080"/>
            </a:xfrm>
            <a:prstGeom prst="rect">
              <a:avLst/>
            </a:prstGeom>
            <a:solidFill>
              <a:srgbClr val="0000ff"/>
            </a:solidFill>
            <a:ln w="468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6311880" y="1877760"/>
              <a:ext cx="316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probcon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1174680" y="755640"/>
              <a:ext cx="127080" cy="12672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0" bIns="432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996840" y="330120"/>
              <a:ext cx="127080" cy="1270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560" bIns="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1352520" y="1777680"/>
              <a:ext cx="127080" cy="1270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560" bIns="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1701720" y="234720"/>
              <a:ext cx="127080" cy="1270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560" bIns="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1879560" y="2266920"/>
              <a:ext cx="127080" cy="12672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0" bIns="432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1523880" y="3517920"/>
              <a:ext cx="127080" cy="12672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0" bIns="432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2057400" y="876240"/>
              <a:ext cx="127080" cy="1270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560" bIns="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2228760" y="234720"/>
              <a:ext cx="127080" cy="1270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560" bIns="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2406600" y="228600"/>
              <a:ext cx="127080" cy="12672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0" bIns="432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2577960" y="228600"/>
              <a:ext cx="127080" cy="12672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0" bIns="432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2755800" y="2393640"/>
              <a:ext cx="127080" cy="1270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560" bIns="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2927520" y="825480"/>
              <a:ext cx="126720" cy="12672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0" bIns="432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3111480" y="660240"/>
              <a:ext cx="127080" cy="1270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560" bIns="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282840" y="1777680"/>
              <a:ext cx="127080" cy="1270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560" bIns="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3460680" y="234720"/>
              <a:ext cx="127080" cy="1270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560" bIns="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3625920" y="1517400"/>
              <a:ext cx="127080" cy="1270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560" bIns="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3803760" y="2914560"/>
              <a:ext cx="127080" cy="1270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560" bIns="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3987720" y="1854000"/>
              <a:ext cx="127080" cy="1270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560" bIns="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4165560" y="450720"/>
              <a:ext cx="127080" cy="1270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560" bIns="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4336920" y="234720"/>
              <a:ext cx="127080" cy="1270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560" bIns="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4508640" y="291960"/>
              <a:ext cx="126720" cy="1270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560" bIns="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4863960" y="228600"/>
              <a:ext cx="127080" cy="12672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0" bIns="432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4686480" y="3949560"/>
              <a:ext cx="126720" cy="1270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560" bIns="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5041800" y="285480"/>
              <a:ext cx="127080" cy="1270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560" bIns="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5213520" y="1682640"/>
              <a:ext cx="126720" cy="1270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560" bIns="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5391000" y="1162080"/>
              <a:ext cx="127080" cy="12672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0" bIns="432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5568840" y="228600"/>
              <a:ext cx="127080" cy="12672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200" bIns="432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5746680" y="393480"/>
              <a:ext cx="127080" cy="1270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560" bIns="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5918040" y="1517400"/>
              <a:ext cx="127080" cy="127080"/>
            </a:xfrm>
            <a:prstGeom prst="ellipse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3560" bIns="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91908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110952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129996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163656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182088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201132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217620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145872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2341440" y="416880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2512800" y="416232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267804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286848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303984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324324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340812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356688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3763800" y="416880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394812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411300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429732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446220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464004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481140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498924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515448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531972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549108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568800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5871960" y="41702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1-23T09:53:47Z</dcterms:created>
  <dc:creator>julie</dc:creator>
  <dc:description/>
  <dc:language>en-US</dc:language>
  <cp:lastModifiedBy>julie</cp:lastModifiedBy>
  <dcterms:modified xsi:type="dcterms:W3CDTF">2008-03-10T12:09:11Z</dcterms:modified>
  <cp:revision>19</cp:revision>
  <dc:subject/>
  <dc:title>Diapositive 1</dc:title>
</cp:coreProperties>
</file>